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7"/>
  </p:notesMasterIdLst>
  <p:sldIdLst>
    <p:sldId id="269" r:id="rId2"/>
    <p:sldId id="287" r:id="rId3"/>
    <p:sldId id="266" r:id="rId4"/>
    <p:sldId id="285" r:id="rId5"/>
    <p:sldId id="291" r:id="rId6"/>
  </p:sldIdLst>
  <p:sldSz cx="6858000" cy="9902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B6D"/>
    <a:srgbClr val="84CDFC"/>
    <a:srgbClr val="BEBEBE"/>
    <a:srgbClr val="C8F8C8"/>
    <a:srgbClr val="DEA0DD"/>
    <a:srgbClr val="C4C4C4"/>
    <a:srgbClr val="FF7B7E"/>
    <a:srgbClr val="93D4FA"/>
    <a:srgbClr val="BDBFD9"/>
    <a:srgbClr val="ECBB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24"/>
    <p:restoredTop sz="94694"/>
  </p:normalViewPr>
  <p:slideViewPr>
    <p:cSldViewPr snapToGrid="0" snapToObjects="1">
      <p:cViewPr>
        <p:scale>
          <a:sx n="138" d="100"/>
          <a:sy n="138" d="100"/>
        </p:scale>
        <p:origin x="215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92C1E8-5593-BF4F-A2BB-CC1DC806EB1D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585-B75E-844C-B909-79E0DDAEF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429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29C585-B75E-844C-B909-79E0DDAEFD4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285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0671"/>
            <a:ext cx="5829300" cy="344765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1276"/>
            <a:ext cx="5143500" cy="239089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133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219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234"/>
            <a:ext cx="1478756" cy="839218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234"/>
            <a:ext cx="4350544" cy="839218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923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08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8832"/>
            <a:ext cx="5915025" cy="411929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7102"/>
            <a:ext cx="5915025" cy="21662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805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856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236"/>
            <a:ext cx="5915025" cy="19140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7568"/>
            <a:ext cx="2901255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7282"/>
            <a:ext cx="2901255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7568"/>
            <a:ext cx="2915543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7282"/>
            <a:ext cx="2915543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395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61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08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5826"/>
            <a:ext cx="3471863" cy="70374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95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5826"/>
            <a:ext cx="3471863" cy="70374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73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057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4.emf"/><Relationship Id="rId4" Type="http://schemas.openxmlformats.org/officeDocument/2006/relationships/package" Target="../embeddings/Microsoft_Excel_Worksheet2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C499ABB8-E5BD-2A45-BFE5-B31893B4B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Materia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1C4B07-F700-4142-8A71-76B8CA86950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2027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814056F-1B28-F644-9792-B829BAC46166}"/>
              </a:ext>
            </a:extLst>
          </p:cNvPr>
          <p:cNvSpPr txBox="1"/>
          <p:nvPr/>
        </p:nvSpPr>
        <p:spPr>
          <a:xfrm>
            <a:off x="544286" y="515257"/>
            <a:ext cx="2199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E629819-026A-C441-811A-C432DF9478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3969143"/>
              </p:ext>
            </p:extLst>
          </p:nvPr>
        </p:nvGraphicFramePr>
        <p:xfrm>
          <a:off x="639891" y="1414365"/>
          <a:ext cx="5578218" cy="70740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8" name="Worksheet" r:id="rId3" imgW="7962900" imgH="10096500" progId="Excel.Sheet.12">
                  <p:embed/>
                </p:oleObj>
              </mc:Choice>
              <mc:Fallback>
                <p:oleObj name="Worksheet" r:id="rId3" imgW="7962900" imgH="100965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9891" y="1414365"/>
                        <a:ext cx="5578218" cy="70740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54418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4">
            <a:extLst>
              <a:ext uri="{FF2B5EF4-FFF2-40B4-BE49-F238E27FC236}">
                <a16:creationId xmlns:a16="http://schemas.microsoft.com/office/drawing/2014/main" id="{6B7817AC-FAB1-DF44-BC55-A46F7846FC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66928" y="2048256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5A7179D-AC72-194F-AC72-5F4F88915C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94904"/>
            <a:ext cx="6858000" cy="3954379"/>
          </a:xfrm>
          <a:prstGeom prst="rect">
            <a:avLst/>
          </a:prstGeom>
        </p:spPr>
      </p:pic>
      <p:sp>
        <p:nvSpPr>
          <p:cNvPr id="7" name="Title 1">
            <a:extLst>
              <a:ext uri="{FF2B5EF4-FFF2-40B4-BE49-F238E27FC236}">
                <a16:creationId xmlns:a16="http://schemas.microsoft.com/office/drawing/2014/main" id="{2C4F0C84-FB97-1E47-8F0A-DC1F48C81F13}"/>
              </a:ext>
            </a:extLst>
          </p:cNvPr>
          <p:cNvSpPr txBox="1">
            <a:spLocks/>
          </p:cNvSpPr>
          <p:nvPr/>
        </p:nvSpPr>
        <p:spPr>
          <a:xfrm>
            <a:off x="376047" y="399639"/>
            <a:ext cx="5915025" cy="1914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/>
              <a:t>Supplemental Table 2</a:t>
            </a:r>
            <a:br>
              <a:rPr lang="en-US" sz="2400" dirty="0"/>
            </a:br>
            <a:r>
              <a:rPr lang="en-US" sz="2400" dirty="0"/>
              <a:t>Zika study cohort</a:t>
            </a:r>
          </a:p>
        </p:txBody>
      </p:sp>
    </p:spTree>
    <p:extLst>
      <p:ext uri="{BB962C8B-B14F-4D97-AF65-F5344CB8AC3E}">
        <p14:creationId xmlns:p14="http://schemas.microsoft.com/office/powerpoint/2010/main" val="35912641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0BC1B82-AD3F-2B41-A7F4-9833B17AFE39}"/>
              </a:ext>
            </a:extLst>
          </p:cNvPr>
          <p:cNvSpPr txBox="1"/>
          <p:nvPr/>
        </p:nvSpPr>
        <p:spPr>
          <a:xfrm>
            <a:off x="0" y="348343"/>
            <a:ext cx="17521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l Table 3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3CB4775-1DD3-3948-8706-FF5D67810E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2760476"/>
              </p:ext>
            </p:extLst>
          </p:nvPr>
        </p:nvGraphicFramePr>
        <p:xfrm>
          <a:off x="2154766" y="-1"/>
          <a:ext cx="2883168" cy="9902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7" name="Worksheet" r:id="rId3" imgW="7670800" imgH="26339800" progId="Excel.Sheet.12">
                  <p:embed/>
                </p:oleObj>
              </mc:Choice>
              <mc:Fallback>
                <p:oleObj name="Worksheet" r:id="rId3" imgW="7670800" imgH="263398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54766" y="-1"/>
                        <a:ext cx="2883168" cy="9902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185766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7ADF43-99A8-0240-9668-EC0D2EBEE6FB}"/>
              </a:ext>
            </a:extLst>
          </p:cNvPr>
          <p:cNvSpPr txBox="1"/>
          <p:nvPr/>
        </p:nvSpPr>
        <p:spPr>
          <a:xfrm>
            <a:off x="736600" y="1371600"/>
            <a:ext cx="2199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4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A442E127-B5DB-674C-96DB-83C7A80E41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9916080"/>
              </p:ext>
            </p:extLst>
          </p:nvPr>
        </p:nvGraphicFramePr>
        <p:xfrm>
          <a:off x="38100" y="1776413"/>
          <a:ext cx="6781800" cy="635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3" name="Worksheet" r:id="rId4" imgW="6781800" imgH="6350000" progId="Excel.Sheet.12">
                  <p:embed/>
                </p:oleObj>
              </mc:Choice>
              <mc:Fallback>
                <p:oleObj name="Worksheet" r:id="rId4" imgW="6781800" imgH="63500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8100" y="1776413"/>
                        <a:ext cx="6781800" cy="635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4924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40</TotalTime>
  <Words>20</Words>
  <Application>Microsoft Macintosh PowerPoint</Application>
  <PresentationFormat>Custom</PresentationFormat>
  <Paragraphs>7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Worksheet</vt:lpstr>
      <vt:lpstr>Microsoft Excel Worksheet</vt:lpstr>
      <vt:lpstr>Supplemental Material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A</dc:title>
  <dc:creator>Mostrom, Matilda</dc:creator>
  <cp:lastModifiedBy>Mostrom, Matilda</cp:lastModifiedBy>
  <cp:revision>274</cp:revision>
  <cp:lastPrinted>2021-06-03T00:31:02Z</cp:lastPrinted>
  <dcterms:created xsi:type="dcterms:W3CDTF">2021-04-26T01:49:06Z</dcterms:created>
  <dcterms:modified xsi:type="dcterms:W3CDTF">2021-07-13T20:59:57Z</dcterms:modified>
</cp:coreProperties>
</file>